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</p:sldIdLst>
  <p:sldSz cx="12192000" cy="63007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00C0"/>
    <a:srgbClr val="CE0665"/>
    <a:srgbClr val="A0A0A4"/>
    <a:srgbClr val="077E97"/>
    <a:srgbClr val="2F5597"/>
    <a:srgbClr val="7C033C"/>
    <a:srgbClr val="D4D4D4"/>
    <a:srgbClr val="EFEF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85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92" y="8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031171"/>
            <a:ext cx="9144000" cy="2193608"/>
          </a:xfrm>
        </p:spPr>
        <p:txBody>
          <a:bodyPr anchor="b"/>
          <a:lstStyle>
            <a:lvl1pPr algn="ctr">
              <a:defRPr sz="5513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309373"/>
            <a:ext cx="9144000" cy="1521231"/>
          </a:xfrm>
        </p:spPr>
        <p:txBody>
          <a:bodyPr/>
          <a:lstStyle>
            <a:lvl1pPr marL="0" indent="0" algn="ctr">
              <a:buNone/>
              <a:defRPr sz="2205"/>
            </a:lvl1pPr>
            <a:lvl2pPr marL="420075" indent="0" algn="ctr">
              <a:buNone/>
              <a:defRPr sz="1838"/>
            </a:lvl2pPr>
            <a:lvl3pPr marL="840151" indent="0" algn="ctr">
              <a:buNone/>
              <a:defRPr sz="1654"/>
            </a:lvl3pPr>
            <a:lvl4pPr marL="1260226" indent="0" algn="ctr">
              <a:buNone/>
              <a:defRPr sz="1470"/>
            </a:lvl4pPr>
            <a:lvl5pPr marL="1680301" indent="0" algn="ctr">
              <a:buNone/>
              <a:defRPr sz="1470"/>
            </a:lvl5pPr>
            <a:lvl6pPr marL="2100377" indent="0" algn="ctr">
              <a:buNone/>
              <a:defRPr sz="1470"/>
            </a:lvl6pPr>
            <a:lvl7pPr marL="2520452" indent="0" algn="ctr">
              <a:buNone/>
              <a:defRPr sz="1470"/>
            </a:lvl7pPr>
            <a:lvl8pPr marL="2940528" indent="0" algn="ctr">
              <a:buNone/>
              <a:defRPr sz="1470"/>
            </a:lvl8pPr>
            <a:lvl9pPr marL="3360603" indent="0" algn="ctr">
              <a:buNone/>
              <a:defRPr sz="147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CD-F33D-41B2-98B6-3C487BCABFB3}" type="datetimeFigureOut">
              <a:rPr lang="en-US" smtClean="0"/>
              <a:t>9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73C07-AF7C-4E2F-99F6-A62C815003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594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CD-F33D-41B2-98B6-3C487BCABFB3}" type="datetimeFigureOut">
              <a:rPr lang="en-US" smtClean="0"/>
              <a:t>9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73C07-AF7C-4E2F-99F6-A62C815003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922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35458"/>
            <a:ext cx="2628900" cy="533962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35458"/>
            <a:ext cx="7734300" cy="533962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CD-F33D-41B2-98B6-3C487BCABFB3}" type="datetimeFigureOut">
              <a:rPr lang="en-US" smtClean="0"/>
              <a:t>9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73C07-AF7C-4E2F-99F6-A62C815003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8215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CD-F33D-41B2-98B6-3C487BCABFB3}" type="datetimeFigureOut">
              <a:rPr lang="en-US" smtClean="0"/>
              <a:t>9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73C07-AF7C-4E2F-99F6-A62C815003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631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570823"/>
            <a:ext cx="10515600" cy="2620952"/>
          </a:xfrm>
        </p:spPr>
        <p:txBody>
          <a:bodyPr anchor="b"/>
          <a:lstStyle>
            <a:lvl1pPr>
              <a:defRPr sz="5513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216570"/>
            <a:ext cx="10515600" cy="1378297"/>
          </a:xfrm>
        </p:spPr>
        <p:txBody>
          <a:bodyPr/>
          <a:lstStyle>
            <a:lvl1pPr marL="0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1pPr>
            <a:lvl2pPr marL="420075" indent="0">
              <a:buNone/>
              <a:defRPr sz="1838">
                <a:solidFill>
                  <a:schemeClr val="tx1">
                    <a:tint val="75000"/>
                  </a:schemeClr>
                </a:solidFill>
              </a:defRPr>
            </a:lvl2pPr>
            <a:lvl3pPr marL="840151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3pPr>
            <a:lvl4pPr marL="1260226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4pPr>
            <a:lvl5pPr marL="1680301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5pPr>
            <a:lvl6pPr marL="2100377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6pPr>
            <a:lvl7pPr marL="2520452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7pPr>
            <a:lvl8pPr marL="2940528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8pPr>
            <a:lvl9pPr marL="3360603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CD-F33D-41B2-98B6-3C487BCABFB3}" type="datetimeFigureOut">
              <a:rPr lang="en-US" smtClean="0"/>
              <a:t>9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73C07-AF7C-4E2F-99F6-A62C815003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183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677293"/>
            <a:ext cx="5181600" cy="3997792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677293"/>
            <a:ext cx="5181600" cy="3997792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CD-F33D-41B2-98B6-3C487BCABFB3}" type="datetimeFigureOut">
              <a:rPr lang="en-US" smtClean="0"/>
              <a:t>9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73C07-AF7C-4E2F-99F6-A62C815003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3707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35459"/>
            <a:ext cx="10515600" cy="1217861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544569"/>
            <a:ext cx="5157787" cy="756969"/>
          </a:xfrm>
        </p:spPr>
        <p:txBody>
          <a:bodyPr anchor="b"/>
          <a:lstStyle>
            <a:lvl1pPr marL="0" indent="0">
              <a:buNone/>
              <a:defRPr sz="2205" b="1"/>
            </a:lvl1pPr>
            <a:lvl2pPr marL="420075" indent="0">
              <a:buNone/>
              <a:defRPr sz="1838" b="1"/>
            </a:lvl2pPr>
            <a:lvl3pPr marL="840151" indent="0">
              <a:buNone/>
              <a:defRPr sz="1654" b="1"/>
            </a:lvl3pPr>
            <a:lvl4pPr marL="1260226" indent="0">
              <a:buNone/>
              <a:defRPr sz="1470" b="1"/>
            </a:lvl4pPr>
            <a:lvl5pPr marL="1680301" indent="0">
              <a:buNone/>
              <a:defRPr sz="1470" b="1"/>
            </a:lvl5pPr>
            <a:lvl6pPr marL="2100377" indent="0">
              <a:buNone/>
              <a:defRPr sz="1470" b="1"/>
            </a:lvl6pPr>
            <a:lvl7pPr marL="2520452" indent="0">
              <a:buNone/>
              <a:defRPr sz="1470" b="1"/>
            </a:lvl7pPr>
            <a:lvl8pPr marL="2940528" indent="0">
              <a:buNone/>
              <a:defRPr sz="1470" b="1"/>
            </a:lvl8pPr>
            <a:lvl9pPr marL="3360603" indent="0">
              <a:buNone/>
              <a:defRPr sz="147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301538"/>
            <a:ext cx="5157787" cy="3385215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544569"/>
            <a:ext cx="5183188" cy="756969"/>
          </a:xfrm>
        </p:spPr>
        <p:txBody>
          <a:bodyPr anchor="b"/>
          <a:lstStyle>
            <a:lvl1pPr marL="0" indent="0">
              <a:buNone/>
              <a:defRPr sz="2205" b="1"/>
            </a:lvl1pPr>
            <a:lvl2pPr marL="420075" indent="0">
              <a:buNone/>
              <a:defRPr sz="1838" b="1"/>
            </a:lvl2pPr>
            <a:lvl3pPr marL="840151" indent="0">
              <a:buNone/>
              <a:defRPr sz="1654" b="1"/>
            </a:lvl3pPr>
            <a:lvl4pPr marL="1260226" indent="0">
              <a:buNone/>
              <a:defRPr sz="1470" b="1"/>
            </a:lvl4pPr>
            <a:lvl5pPr marL="1680301" indent="0">
              <a:buNone/>
              <a:defRPr sz="1470" b="1"/>
            </a:lvl5pPr>
            <a:lvl6pPr marL="2100377" indent="0">
              <a:buNone/>
              <a:defRPr sz="1470" b="1"/>
            </a:lvl6pPr>
            <a:lvl7pPr marL="2520452" indent="0">
              <a:buNone/>
              <a:defRPr sz="1470" b="1"/>
            </a:lvl7pPr>
            <a:lvl8pPr marL="2940528" indent="0">
              <a:buNone/>
              <a:defRPr sz="1470" b="1"/>
            </a:lvl8pPr>
            <a:lvl9pPr marL="3360603" indent="0">
              <a:buNone/>
              <a:defRPr sz="147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301538"/>
            <a:ext cx="5183188" cy="3385215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CD-F33D-41B2-98B6-3C487BCABFB3}" type="datetimeFigureOut">
              <a:rPr lang="en-US" smtClean="0"/>
              <a:t>9/9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73C07-AF7C-4E2F-99F6-A62C815003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044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CD-F33D-41B2-98B6-3C487BCABFB3}" type="datetimeFigureOut">
              <a:rPr lang="en-US" smtClean="0"/>
              <a:t>9/9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73C07-AF7C-4E2F-99F6-A62C815003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425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CD-F33D-41B2-98B6-3C487BCABFB3}" type="datetimeFigureOut">
              <a:rPr lang="en-US" smtClean="0"/>
              <a:t>9/9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73C07-AF7C-4E2F-99F6-A62C815003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943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20052"/>
            <a:ext cx="3932237" cy="1470184"/>
          </a:xfrm>
        </p:spPr>
        <p:txBody>
          <a:bodyPr anchor="b"/>
          <a:lstStyle>
            <a:lvl1pPr>
              <a:defRPr sz="294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07197"/>
            <a:ext cx="6172200" cy="4477643"/>
          </a:xfrm>
        </p:spPr>
        <p:txBody>
          <a:bodyPr/>
          <a:lstStyle>
            <a:lvl1pPr>
              <a:defRPr sz="2940"/>
            </a:lvl1pPr>
            <a:lvl2pPr>
              <a:defRPr sz="2573"/>
            </a:lvl2pPr>
            <a:lvl3pPr>
              <a:defRPr sz="2205"/>
            </a:lvl3pPr>
            <a:lvl4pPr>
              <a:defRPr sz="1838"/>
            </a:lvl4pPr>
            <a:lvl5pPr>
              <a:defRPr sz="1838"/>
            </a:lvl5pPr>
            <a:lvl6pPr>
              <a:defRPr sz="1838"/>
            </a:lvl6pPr>
            <a:lvl7pPr>
              <a:defRPr sz="1838"/>
            </a:lvl7pPr>
            <a:lvl8pPr>
              <a:defRPr sz="1838"/>
            </a:lvl8pPr>
            <a:lvl9pPr>
              <a:defRPr sz="1838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1890236"/>
            <a:ext cx="3932237" cy="3501897"/>
          </a:xfrm>
        </p:spPr>
        <p:txBody>
          <a:bodyPr/>
          <a:lstStyle>
            <a:lvl1pPr marL="0" indent="0">
              <a:buNone/>
              <a:defRPr sz="1470"/>
            </a:lvl1pPr>
            <a:lvl2pPr marL="420075" indent="0">
              <a:buNone/>
              <a:defRPr sz="1286"/>
            </a:lvl2pPr>
            <a:lvl3pPr marL="840151" indent="0">
              <a:buNone/>
              <a:defRPr sz="1103"/>
            </a:lvl3pPr>
            <a:lvl4pPr marL="1260226" indent="0">
              <a:buNone/>
              <a:defRPr sz="919"/>
            </a:lvl4pPr>
            <a:lvl5pPr marL="1680301" indent="0">
              <a:buNone/>
              <a:defRPr sz="919"/>
            </a:lvl5pPr>
            <a:lvl6pPr marL="2100377" indent="0">
              <a:buNone/>
              <a:defRPr sz="919"/>
            </a:lvl6pPr>
            <a:lvl7pPr marL="2520452" indent="0">
              <a:buNone/>
              <a:defRPr sz="919"/>
            </a:lvl7pPr>
            <a:lvl8pPr marL="2940528" indent="0">
              <a:buNone/>
              <a:defRPr sz="919"/>
            </a:lvl8pPr>
            <a:lvl9pPr marL="3360603" indent="0">
              <a:buNone/>
              <a:defRPr sz="919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CD-F33D-41B2-98B6-3C487BCABFB3}" type="datetimeFigureOut">
              <a:rPr lang="en-US" smtClean="0"/>
              <a:t>9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73C07-AF7C-4E2F-99F6-A62C815003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053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20052"/>
            <a:ext cx="3932237" cy="1470184"/>
          </a:xfrm>
        </p:spPr>
        <p:txBody>
          <a:bodyPr anchor="b"/>
          <a:lstStyle>
            <a:lvl1pPr>
              <a:defRPr sz="294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07197"/>
            <a:ext cx="6172200" cy="4477643"/>
          </a:xfrm>
        </p:spPr>
        <p:txBody>
          <a:bodyPr anchor="t"/>
          <a:lstStyle>
            <a:lvl1pPr marL="0" indent="0">
              <a:buNone/>
              <a:defRPr sz="2940"/>
            </a:lvl1pPr>
            <a:lvl2pPr marL="420075" indent="0">
              <a:buNone/>
              <a:defRPr sz="2573"/>
            </a:lvl2pPr>
            <a:lvl3pPr marL="840151" indent="0">
              <a:buNone/>
              <a:defRPr sz="2205"/>
            </a:lvl3pPr>
            <a:lvl4pPr marL="1260226" indent="0">
              <a:buNone/>
              <a:defRPr sz="1838"/>
            </a:lvl4pPr>
            <a:lvl5pPr marL="1680301" indent="0">
              <a:buNone/>
              <a:defRPr sz="1838"/>
            </a:lvl5pPr>
            <a:lvl6pPr marL="2100377" indent="0">
              <a:buNone/>
              <a:defRPr sz="1838"/>
            </a:lvl6pPr>
            <a:lvl7pPr marL="2520452" indent="0">
              <a:buNone/>
              <a:defRPr sz="1838"/>
            </a:lvl7pPr>
            <a:lvl8pPr marL="2940528" indent="0">
              <a:buNone/>
              <a:defRPr sz="1838"/>
            </a:lvl8pPr>
            <a:lvl9pPr marL="3360603" indent="0">
              <a:buNone/>
              <a:defRPr sz="1838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1890236"/>
            <a:ext cx="3932237" cy="3501897"/>
          </a:xfrm>
        </p:spPr>
        <p:txBody>
          <a:bodyPr/>
          <a:lstStyle>
            <a:lvl1pPr marL="0" indent="0">
              <a:buNone/>
              <a:defRPr sz="1470"/>
            </a:lvl1pPr>
            <a:lvl2pPr marL="420075" indent="0">
              <a:buNone/>
              <a:defRPr sz="1286"/>
            </a:lvl2pPr>
            <a:lvl3pPr marL="840151" indent="0">
              <a:buNone/>
              <a:defRPr sz="1103"/>
            </a:lvl3pPr>
            <a:lvl4pPr marL="1260226" indent="0">
              <a:buNone/>
              <a:defRPr sz="919"/>
            </a:lvl4pPr>
            <a:lvl5pPr marL="1680301" indent="0">
              <a:buNone/>
              <a:defRPr sz="919"/>
            </a:lvl5pPr>
            <a:lvl6pPr marL="2100377" indent="0">
              <a:buNone/>
              <a:defRPr sz="919"/>
            </a:lvl6pPr>
            <a:lvl7pPr marL="2520452" indent="0">
              <a:buNone/>
              <a:defRPr sz="919"/>
            </a:lvl7pPr>
            <a:lvl8pPr marL="2940528" indent="0">
              <a:buNone/>
              <a:defRPr sz="919"/>
            </a:lvl8pPr>
            <a:lvl9pPr marL="3360603" indent="0">
              <a:buNone/>
              <a:defRPr sz="919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E9FCD-F33D-41B2-98B6-3C487BCABFB3}" type="datetimeFigureOut">
              <a:rPr lang="en-US" smtClean="0"/>
              <a:t>9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73C07-AF7C-4E2F-99F6-A62C815003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233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35459"/>
            <a:ext cx="10515600" cy="1217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677293"/>
            <a:ext cx="10515600" cy="39977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5839897"/>
            <a:ext cx="2743200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7E9FCD-F33D-41B2-98B6-3C487BCABFB3}" type="datetimeFigureOut">
              <a:rPr lang="en-US" smtClean="0"/>
              <a:t>9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5839897"/>
            <a:ext cx="4114800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5839897"/>
            <a:ext cx="2743200" cy="3354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973C07-AF7C-4E2F-99F6-A62C815003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643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40151" rtl="0" eaLnBrk="1" latinLnBrk="0" hangingPunct="1">
        <a:lnSpc>
          <a:spcPct val="90000"/>
        </a:lnSpc>
        <a:spcBef>
          <a:spcPct val="0"/>
        </a:spcBef>
        <a:buNone/>
        <a:defRPr sz="404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0038" indent="-210038" algn="l" defTabSz="840151" rtl="0" eaLnBrk="1" latinLnBrk="0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2573" kern="1200">
          <a:solidFill>
            <a:schemeClr val="tx1"/>
          </a:solidFill>
          <a:latin typeface="+mn-lt"/>
          <a:ea typeface="+mn-ea"/>
          <a:cs typeface="+mn-cs"/>
        </a:defRPr>
      </a:lvl1pPr>
      <a:lvl2pPr marL="630113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2pPr>
      <a:lvl3pPr marL="1050188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838" kern="1200">
          <a:solidFill>
            <a:schemeClr val="tx1"/>
          </a:solidFill>
          <a:latin typeface="+mn-lt"/>
          <a:ea typeface="+mn-ea"/>
          <a:cs typeface="+mn-cs"/>
        </a:defRPr>
      </a:lvl3pPr>
      <a:lvl4pPr marL="1470264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4pPr>
      <a:lvl5pPr marL="1890339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5pPr>
      <a:lvl6pPr marL="2310414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6pPr>
      <a:lvl7pPr marL="2730490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7pPr>
      <a:lvl8pPr marL="3150565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8pPr>
      <a:lvl9pPr marL="3570641" indent="-210038" algn="l" defTabSz="840151" rtl="0" eaLnBrk="1" latinLnBrk="0" hangingPunct="1">
        <a:lnSpc>
          <a:spcPct val="90000"/>
        </a:lnSpc>
        <a:spcBef>
          <a:spcPts val="459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1pPr>
      <a:lvl2pPr marL="420075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2pPr>
      <a:lvl3pPr marL="840151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3pPr>
      <a:lvl4pPr marL="1260226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4pPr>
      <a:lvl5pPr marL="1680301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5pPr>
      <a:lvl6pPr marL="2100377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6pPr>
      <a:lvl7pPr marL="2520452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7pPr>
      <a:lvl8pPr marL="2940528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8pPr>
      <a:lvl9pPr marL="3360603" algn="l" defTabSz="840151" rtl="0" eaLnBrk="1" latinLnBrk="0" hangingPunct="1">
        <a:defRPr sz="165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B751B0F5-D427-AC40-BBE3-D07A60AD3B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133" y="365750"/>
            <a:ext cx="5435600" cy="2311400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993493EF-44C9-8949-B9C2-CCB0D25A11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883" y="3812344"/>
            <a:ext cx="5118100" cy="2311400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56E60212-5C1A-3F40-A1DD-75A00FE78415}"/>
              </a:ext>
            </a:extLst>
          </p:cNvPr>
          <p:cNvSpPr txBox="1"/>
          <p:nvPr/>
        </p:nvSpPr>
        <p:spPr>
          <a:xfrm>
            <a:off x="7208679" y="365750"/>
            <a:ext cx="358059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/>
              <a:t>120 </a:t>
            </a:r>
            <a:r>
              <a:rPr lang="fr-FR" sz="1600" b="1" dirty="0" err="1"/>
              <a:t>children</a:t>
            </a:r>
            <a:r>
              <a:rPr lang="fr-FR" sz="1600" b="1" dirty="0"/>
              <a:t> </a:t>
            </a:r>
            <a:r>
              <a:rPr lang="fr-FR" sz="1600" b="1" dirty="0" err="1"/>
              <a:t>with</a:t>
            </a:r>
            <a:r>
              <a:rPr lang="fr-FR" sz="1600" b="1"/>
              <a:t> available</a:t>
            </a:r>
            <a:r>
              <a:rPr lang="fr-FR" sz="1600" b="1" dirty="0"/>
              <a:t> </a:t>
            </a:r>
            <a:r>
              <a:rPr lang="fr-FR" sz="1600" b="1" dirty="0" err="1"/>
              <a:t>liver</a:t>
            </a:r>
            <a:r>
              <a:rPr lang="fr-FR" sz="1600" b="1" dirty="0"/>
              <a:t> </a:t>
            </a:r>
            <a:r>
              <a:rPr lang="fr-FR" sz="1600" b="1" dirty="0" err="1"/>
              <a:t>graft</a:t>
            </a:r>
            <a:r>
              <a:rPr lang="fr-FR" sz="1600" b="1" dirty="0"/>
              <a:t> biopsies </a:t>
            </a:r>
            <a:r>
              <a:rPr lang="fr-FR" sz="1600" b="1" dirty="0" err="1"/>
              <a:t>after</a:t>
            </a:r>
            <a:r>
              <a:rPr lang="fr-FR" sz="1600" b="1" dirty="0"/>
              <a:t> transplantation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DD8883F3-EFA0-D441-A06C-D4BFE6DFA3B9}"/>
              </a:ext>
            </a:extLst>
          </p:cNvPr>
          <p:cNvSpPr txBox="1"/>
          <p:nvPr/>
        </p:nvSpPr>
        <p:spPr>
          <a:xfrm>
            <a:off x="6288355" y="1290066"/>
            <a:ext cx="55606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/>
              <a:t>Emultated</a:t>
            </a:r>
            <a:r>
              <a:rPr lang="en-US" sz="1600" b="1" dirty="0"/>
              <a:t> target trial  (G estimation) :</a:t>
            </a:r>
          </a:p>
          <a:p>
            <a:pPr algn="ctr"/>
            <a:r>
              <a:rPr lang="en-US" sz="1600" b="1" dirty="0"/>
              <a:t>donor HED-class 1 is an independent predictor of late rejection</a:t>
            </a:r>
            <a:endParaRPr lang="fr-FR" sz="1600" dirty="0"/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id="{E9CD3632-F2A6-BE49-B5AB-5CADC1632C3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64038" y="1925021"/>
            <a:ext cx="6069874" cy="4047847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29702530-7630-7947-9F75-08BBC5396706}"/>
              </a:ext>
            </a:extLst>
          </p:cNvPr>
          <p:cNvSpPr txBox="1"/>
          <p:nvPr/>
        </p:nvSpPr>
        <p:spPr>
          <a:xfrm>
            <a:off x="362883" y="3104905"/>
            <a:ext cx="385687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HED (HLA </a:t>
            </a:r>
            <a:r>
              <a:rPr lang="fr-FR" sz="1600" b="1" dirty="0" err="1"/>
              <a:t>Evolutionary</a:t>
            </a:r>
            <a:r>
              <a:rPr lang="fr-FR" sz="1600" b="1" dirty="0"/>
              <a:t> Divergence) </a:t>
            </a:r>
          </a:p>
          <a:p>
            <a:r>
              <a:rPr lang="fr-FR" sz="1600" b="1" dirty="0" err="1"/>
              <a:t>Grantham’s</a:t>
            </a:r>
            <a:r>
              <a:rPr lang="fr-FR" sz="1600" b="1" dirty="0"/>
              <a:t> </a:t>
            </a:r>
            <a:r>
              <a:rPr lang="fr-FR" sz="1600" b="1" dirty="0" err="1"/>
              <a:t>interallelic</a:t>
            </a:r>
            <a:r>
              <a:rPr lang="fr-FR" sz="1600" b="1" dirty="0"/>
              <a:t> </a:t>
            </a:r>
            <a:r>
              <a:rPr lang="fr-FR" sz="1600" b="1" dirty="0" err="1"/>
              <a:t>aminoacid</a:t>
            </a:r>
            <a:r>
              <a:rPr lang="fr-FR" sz="1600" b="1" dirty="0"/>
              <a:t> distance 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B9753CB-062C-F14D-B40E-33650880C5BA}"/>
              </a:ext>
            </a:extLst>
          </p:cNvPr>
          <p:cNvSpPr/>
          <p:nvPr/>
        </p:nvSpPr>
        <p:spPr>
          <a:xfrm>
            <a:off x="5964038" y="1925021"/>
            <a:ext cx="648635" cy="3498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B2DCD49A-1A68-6042-9D76-12F8B47A227C}"/>
              </a:ext>
            </a:extLst>
          </p:cNvPr>
          <p:cNvSpPr txBox="1"/>
          <p:nvPr/>
        </p:nvSpPr>
        <p:spPr>
          <a:xfrm rot="16200000">
            <a:off x="5134436" y="3768441"/>
            <a:ext cx="315579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Rejection free </a:t>
            </a:r>
            <a:r>
              <a:rPr lang="fr-FR" dirty="0" err="1"/>
              <a:t>survival</a:t>
            </a:r>
            <a:endParaRPr lang="fr-FR" dirty="0"/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A477558C-EFC6-3B4D-AF84-9B03E7AEDB55}"/>
              </a:ext>
            </a:extLst>
          </p:cNvPr>
          <p:cNvSpPr txBox="1"/>
          <p:nvPr/>
        </p:nvSpPr>
        <p:spPr>
          <a:xfrm rot="16200000">
            <a:off x="7645677" y="3758147"/>
            <a:ext cx="315579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dirty="0">
                <a:solidFill>
                  <a:schemeClr val="bg1"/>
                </a:solidFill>
              </a:rPr>
              <a:t>Rejection free </a:t>
            </a:r>
            <a:r>
              <a:rPr lang="fr-FR" dirty="0" err="1">
                <a:solidFill>
                  <a:schemeClr val="bg1"/>
                </a:solidFill>
              </a:rPr>
              <a:t>survival</a:t>
            </a:r>
            <a:endParaRPr lang="fr-FR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5255515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77</TotalTime>
  <Words>43</Words>
  <Application>Microsoft Macintosh PowerPoint</Application>
  <PresentationFormat>Personnalisé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evalier</dc:creator>
  <cp:lastModifiedBy>FERAY</cp:lastModifiedBy>
  <cp:revision>201</cp:revision>
  <cp:lastPrinted>2023-12-21T13:33:24Z</cp:lastPrinted>
  <dcterms:created xsi:type="dcterms:W3CDTF">2023-05-30T16:26:57Z</dcterms:created>
  <dcterms:modified xsi:type="dcterms:W3CDTF">2024-09-09T10:02:26Z</dcterms:modified>
</cp:coreProperties>
</file>